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54BB76F-F15F-4B6A-8BE7-EA37EB786DD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B5B62FD-5FD8-4AB4-9D70-FE348539801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D73490E-C24A-4207-8C95-9544EB7A1F0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7168927-FD3B-4DEA-AD14-0AE91723B2C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557BD5F-CB2B-4B46-A4F2-7535F85E075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DC4796-00D7-4A28-8C3D-DDD03AE7C6B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5E5BE61-E04C-4C22-BA1A-E3A3A3D92F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E228DE5-7A50-4ED6-8CD2-550D57669D1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A99F6C0-1990-48D0-8656-94E77D770DA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D9325B3-1C7F-4386-9CB3-DD8B9AE9352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3133F02-A11A-4DD9-BF47-AE449CBCCC1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7CBE07A-12F9-44EA-9C89-C2CC8C43684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C3DADCD-A56F-43F0-8738-026029F78096}" type="slidenum">
              <a:rPr b="0" lang="zh-TW"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圖片 6" descr="shift reading frame_02.eps"/>
          <p:cNvPicPr/>
          <p:nvPr/>
        </p:nvPicPr>
        <p:blipFill>
          <a:blip r:embed="rId1"/>
          <a:stretch/>
        </p:blipFill>
        <p:spPr>
          <a:xfrm>
            <a:off x="1476360" y="719280"/>
            <a:ext cx="6674040" cy="2498760"/>
          </a:xfrm>
          <a:prstGeom prst="rect">
            <a:avLst/>
          </a:prstGeom>
          <a:ln w="0">
            <a:noFill/>
          </a:ln>
        </p:spPr>
      </p:pic>
      <p:sp>
        <p:nvSpPr>
          <p:cNvPr id="42" name="文字方塊 3"/>
          <p:cNvSpPr/>
          <p:nvPr/>
        </p:nvSpPr>
        <p:spPr>
          <a:xfrm>
            <a:off x="1190880" y="2011320"/>
            <a:ext cx="383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B)</a:t>
            </a:r>
            <a:endParaRPr b="0" lang="en-US" sz="1200" spc="-1" strike="noStrike">
              <a:solidFill>
                <a:srgbClr val="000000"/>
              </a:solidFill>
              <a:latin typeface="Arial"/>
            </a:endParaRPr>
          </a:p>
        </p:txBody>
      </p:sp>
      <p:sp>
        <p:nvSpPr>
          <p:cNvPr id="43" name="文字方塊 2"/>
          <p:cNvSpPr/>
          <p:nvPr/>
        </p:nvSpPr>
        <p:spPr>
          <a:xfrm>
            <a:off x="1145160" y="642960"/>
            <a:ext cx="390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a:t>
            </a:r>
            <a:endParaRPr b="0" lang="en-US" sz="1200" spc="-1" strike="noStrike">
              <a:solidFill>
                <a:srgbClr val="000000"/>
              </a:solidFill>
              <a:latin typeface="Arial"/>
            </a:endParaRPr>
          </a:p>
        </p:txBody>
      </p:sp>
      <p:sp>
        <p:nvSpPr>
          <p:cNvPr id="44" name=""/>
          <p:cNvSpPr/>
          <p:nvPr/>
        </p:nvSpPr>
        <p:spPr>
          <a:xfrm>
            <a:off x="1219320" y="4114800"/>
            <a:ext cx="6781680" cy="1628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TW" sz="1200" spc="-1" strike="noStrike">
                <a:solidFill>
                  <a:srgbClr val="000000"/>
                </a:solidFill>
                <a:latin typeface="Times New Roman"/>
              </a:rPr>
              <a:t>Figure S2  Predicted T</a:t>
            </a:r>
            <a:r>
              <a:rPr b="1" lang="zh-TW" sz="1200" spc="-1" strike="noStrike" baseline="-25000">
                <a:solidFill>
                  <a:srgbClr val="000000"/>
                </a:solidFill>
                <a:latin typeface="Times New Roman"/>
              </a:rPr>
              <a:t>7</a:t>
            </a:r>
            <a:r>
              <a:rPr b="1" lang="zh-TW" sz="1200" spc="-1" strike="noStrike">
                <a:solidFill>
                  <a:srgbClr val="000000"/>
                </a:solidFill>
                <a:latin typeface="Times New Roman"/>
              </a:rPr>
              <a:t>G translational frameshift sites in Smp131 and closely related prophages from </a:t>
            </a:r>
            <a:r>
              <a:rPr b="1" i="1" lang="zh-TW" sz="1200" spc="-1" strike="noStrike">
                <a:solidFill>
                  <a:srgbClr val="000000"/>
                </a:solidFill>
                <a:latin typeface="Times New Roman"/>
              </a:rPr>
              <a:t>Xanthomoas</a:t>
            </a:r>
            <a:r>
              <a:rPr b="1" lang="zh-TW" sz="1200" spc="-1" strike="noStrike">
                <a:solidFill>
                  <a:srgbClr val="000000"/>
                </a:solidFill>
                <a:latin typeface="Times New Roman"/>
              </a:rPr>
              <a:t> and </a:t>
            </a:r>
            <a:r>
              <a:rPr b="1" i="1" lang="zh-TW" sz="1200" spc="-1" strike="noStrike">
                <a:solidFill>
                  <a:srgbClr val="000000"/>
                </a:solidFill>
                <a:latin typeface="Times New Roman"/>
              </a:rPr>
              <a:t>Stenotrophomonas</a:t>
            </a:r>
            <a:r>
              <a:rPr b="1" lang="zh-TW" sz="1200" spc="-1" strike="noStrike">
                <a:solidFill>
                  <a:srgbClr val="000000"/>
                </a:solidFill>
                <a:latin typeface="Times New Roman"/>
              </a:rPr>
              <a:t>.</a:t>
            </a:r>
            <a:r>
              <a:rPr b="0" lang="zh-TW" sz="1200" spc="-1" strike="noStrike">
                <a:solidFill>
                  <a:srgbClr val="000000"/>
                </a:solidFill>
                <a:latin typeface="Times New Roman"/>
              </a:rPr>
              <a:t> (A) T</a:t>
            </a:r>
            <a:r>
              <a:rPr b="0" lang="zh-TW" sz="1200" spc="-1" strike="noStrike" baseline="-25000">
                <a:solidFill>
                  <a:srgbClr val="000000"/>
                </a:solidFill>
                <a:latin typeface="Times New Roman"/>
              </a:rPr>
              <a:t>7</a:t>
            </a:r>
            <a:r>
              <a:rPr b="0" lang="zh-TW" sz="1200" spc="-1" strike="noStrike">
                <a:solidFill>
                  <a:srgbClr val="000000"/>
                </a:solidFill>
                <a:latin typeface="Times New Roman"/>
              </a:rPr>
              <a:t>G (enclosed by a rectangle) and the surrounding regions including genes p27, p27.1 and p28 of Smp131.  Stop codons are denoted by three dots after the amino acids.  Predicted start codon ATG of p27.1 is underlined, whereas ribosomal binding site AGAGG for gene p28 is in gray background. (B) DNA sequence alignment of the regions surrounding T</a:t>
            </a:r>
            <a:r>
              <a:rPr b="0" lang="zh-TW" sz="1200" spc="-1" strike="noStrike" baseline="-25000">
                <a:solidFill>
                  <a:srgbClr val="000000"/>
                </a:solidFill>
                <a:latin typeface="Times New Roman"/>
              </a:rPr>
              <a:t>7</a:t>
            </a:r>
            <a:r>
              <a:rPr b="0" lang="zh-TW" sz="1200" spc="-1" strike="noStrike">
                <a:solidFill>
                  <a:srgbClr val="000000"/>
                </a:solidFill>
                <a:latin typeface="Times New Roman"/>
              </a:rPr>
              <a:t>G translational frameshift sites (enclosed in rectangles) from Smp131 and the related prophages from </a:t>
            </a:r>
            <a:r>
              <a:rPr b="0" i="1" lang="zh-TW" sz="1200" spc="-1" strike="noStrike">
                <a:solidFill>
                  <a:srgbClr val="000000"/>
                </a:solidFill>
                <a:latin typeface="Times New Roman"/>
              </a:rPr>
              <a:t>X. campestris</a:t>
            </a:r>
            <a:r>
              <a:rPr b="0" lang="zh-TW" sz="1200" spc="-1" strike="noStrike">
                <a:solidFill>
                  <a:srgbClr val="000000"/>
                </a:solidFill>
                <a:latin typeface="Times New Roman"/>
              </a:rPr>
              <a:t> pv. campestris 33913, </a:t>
            </a:r>
            <a:r>
              <a:rPr b="0" i="1" lang="zh-TW" sz="1200" spc="-1" strike="noStrike">
                <a:solidFill>
                  <a:srgbClr val="000000"/>
                </a:solidFill>
                <a:latin typeface="Times New Roman"/>
              </a:rPr>
              <a:t>X. oryzae</a:t>
            </a:r>
            <a:r>
              <a:rPr b="0" lang="zh-TW" sz="1200" spc="-1" strike="noStrike">
                <a:solidFill>
                  <a:srgbClr val="000000"/>
                </a:solidFill>
                <a:latin typeface="Times New Roman"/>
              </a:rPr>
              <a:t> pv. oryzae strains KACC10331, MAFF311018 and PXO99A. An asterisk indicates identical nucleotides in all phage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user</cp:lastModifiedBy>
  <dcterms:modified xsi:type="dcterms:W3CDTF">2014-01-12T09:53:50Z</dcterms:modified>
  <cp:revision>6</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